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D4AB0-8DAC-4DCD-B741-CA9D046834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D148AF-E61A-4574-8B33-E554A6FD70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56EB0-8611-4625-84FC-B2B709A300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62C534-4451-4827-94D9-6DD10E404C0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35DD4-54BC-4960-A831-7C4EB69B89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C7C49-7929-49EE-86CC-25BC2F2E64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5182A-10EB-4897-8C0C-0E8C52D3AC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6A92D-B24A-4A4E-92D3-875138F12D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EF86CD-1B88-4D17-9814-70E9CDC78E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5F362-6B64-40A2-8E40-E1822457CA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694659-F0C8-4EC0-AA2C-12E01781BC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8CD4D-770D-43F3-AE83-833AADD3CB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623AF6-24BD-4FB2-BC58-0B1C3E4E27E7}" type="slidenum">
              <a:rPr b="0" lang="en-A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07640" y="189000"/>
            <a:ext cx="6335640" cy="5061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: PD-1 and Integrin </a:t>
            </a:r>
            <a:r>
              <a:rPr b="0" lang="en-AU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 staining on CD4+ T lymphocyt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5651640" y="1413000"/>
            <a:ext cx="2871720" cy="27288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"/>
          <p:cNvPicPr/>
          <p:nvPr/>
        </p:nvPicPr>
        <p:blipFill>
          <a:blip r:embed="rId2"/>
          <a:stretch/>
        </p:blipFill>
        <p:spPr>
          <a:xfrm>
            <a:off x="404640" y="1413000"/>
            <a:ext cx="2872080" cy="27288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"/>
          <p:cNvPicPr/>
          <p:nvPr/>
        </p:nvPicPr>
        <p:blipFill>
          <a:blip r:embed="rId3"/>
          <a:stretch/>
        </p:blipFill>
        <p:spPr>
          <a:xfrm>
            <a:off x="3059280" y="1413000"/>
            <a:ext cx="2871720" cy="2728800"/>
          </a:xfrm>
          <a:prstGeom prst="rect">
            <a:avLst/>
          </a:prstGeom>
          <a:ln w="0">
            <a:noFill/>
          </a:ln>
        </p:spPr>
      </p:pic>
      <p:sp>
        <p:nvSpPr>
          <p:cNvPr id="45" name="TextBox 3"/>
          <p:cNvSpPr/>
          <p:nvPr/>
        </p:nvSpPr>
        <p:spPr>
          <a:xfrm>
            <a:off x="1192320" y="1197000"/>
            <a:ext cx="150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1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-1 F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3855960" y="1197000"/>
            <a:ext cx="150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1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 FM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6443640" y="1197000"/>
            <a:ext cx="150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1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oth stai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8" name="Straight Arrow Connector 5"/>
          <p:cNvCxnSpPr/>
          <p:nvPr/>
        </p:nvCxnSpPr>
        <p:spPr>
          <a:xfrm flipV="1">
            <a:off x="539280" y="3141360"/>
            <a:ext cx="1080" cy="108000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9" name="Straight Arrow Connector 7"/>
          <p:cNvCxnSpPr/>
          <p:nvPr/>
        </p:nvCxnSpPr>
        <p:spPr>
          <a:xfrm>
            <a:off x="539280" y="4220640"/>
            <a:ext cx="1080360" cy="1080"/>
          </a:xfrm>
          <a:prstGeom prst="straightConnector1">
            <a:avLst/>
          </a:prstGeom>
          <a:ln w="2844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0" name="TextBox 13"/>
          <p:cNvSpPr/>
          <p:nvPr/>
        </p:nvSpPr>
        <p:spPr>
          <a:xfrm>
            <a:off x="504720" y="4248000"/>
            <a:ext cx="1079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7 FIT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8"/>
          <p:cNvSpPr/>
          <p:nvPr/>
        </p:nvSpPr>
        <p:spPr>
          <a:xfrm rot="16200000">
            <a:off x="-878040" y="3554640"/>
            <a:ext cx="2403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D-1 PE-Cy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31T09:38:43Z</dcterms:created>
  <dc:creator>Miranda Smith</dc:creator>
  <dc:description/>
  <dc:language>en-US</dc:language>
  <cp:lastModifiedBy>Miranda Smith</cp:lastModifiedBy>
  <dcterms:modified xsi:type="dcterms:W3CDTF">2013-01-31T10:22:43Z</dcterms:modified>
  <cp:revision>3</cp:revision>
  <dc:subject/>
  <dc:title>Supplemental Figure 1: PD-1 and Integrin b7 staining</dc:title>
</cp:coreProperties>
</file>